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-1500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oice\Desktop\Helena_paper12\Supplementary%20Figure%201%20(1)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pt-B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SupplementaryFigure1!$A$3</c:f>
              <c:strCache>
                <c:ptCount val="1"/>
                <c:pt idx="0">
                  <c:v>E. coli</c:v>
                </c:pt>
              </c:strCache>
            </c:strRef>
          </c:tx>
          <c:spPr>
            <a:solidFill>
              <a:srgbClr val="0066FF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SupplementaryFigure1!$B$2:$M$2</c:f>
              <c:strCache>
                <c:ptCount val="12"/>
                <c:pt idx="0">
                  <c:v>TEM</c:v>
                </c:pt>
                <c:pt idx="1">
                  <c:v>SHV</c:v>
                </c:pt>
                <c:pt idx="2">
                  <c:v>OXA1</c:v>
                </c:pt>
                <c:pt idx="3">
                  <c:v>CTX-1</c:v>
                </c:pt>
                <c:pt idx="4">
                  <c:v>CTX-2</c:v>
                </c:pt>
                <c:pt idx="5">
                  <c:v>CTX-9</c:v>
                </c:pt>
                <c:pt idx="6">
                  <c:v>GES</c:v>
                </c:pt>
                <c:pt idx="7">
                  <c:v>OXA48</c:v>
                </c:pt>
                <c:pt idx="8">
                  <c:v>KPC</c:v>
                </c:pt>
                <c:pt idx="9">
                  <c:v>VIM</c:v>
                </c:pt>
                <c:pt idx="10">
                  <c:v>NDM</c:v>
                </c:pt>
                <c:pt idx="11">
                  <c:v>OXA23</c:v>
                </c:pt>
              </c:strCache>
            </c:strRef>
          </c:cat>
          <c:val>
            <c:numRef>
              <c:f>SupplementaryFigure1!$B$3:$M$3</c:f>
              <c:numCache>
                <c:formatCode>General</c:formatCode>
                <c:ptCount val="12"/>
                <c:pt idx="0">
                  <c:v>21</c:v>
                </c:pt>
                <c:pt idx="1">
                  <c:v>4</c:v>
                </c:pt>
                <c:pt idx="2">
                  <c:v>4</c:v>
                </c:pt>
                <c:pt idx="3">
                  <c:v>6</c:v>
                </c:pt>
                <c:pt idx="4">
                  <c:v>1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</c:v>
                </c:pt>
                <c:pt idx="9">
                  <c:v>0</c:v>
                </c:pt>
                <c:pt idx="10">
                  <c:v>1</c:v>
                </c:pt>
                <c:pt idx="11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2526-41E4-820E-7EF1E157EA9A}"/>
            </c:ext>
          </c:extLst>
        </c:ser>
        <c:ser>
          <c:idx val="1"/>
          <c:order val="1"/>
          <c:tx>
            <c:strRef>
              <c:f>SupplementaryFigure1!$A$4</c:f>
              <c:strCache>
                <c:ptCount val="1"/>
                <c:pt idx="0">
                  <c:v>K. pneumoniae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SupplementaryFigure1!$B$2:$M$2</c:f>
              <c:strCache>
                <c:ptCount val="12"/>
                <c:pt idx="0">
                  <c:v>TEM</c:v>
                </c:pt>
                <c:pt idx="1">
                  <c:v>SHV</c:v>
                </c:pt>
                <c:pt idx="2">
                  <c:v>OXA1</c:v>
                </c:pt>
                <c:pt idx="3">
                  <c:v>CTX-1</c:v>
                </c:pt>
                <c:pt idx="4">
                  <c:v>CTX-2</c:v>
                </c:pt>
                <c:pt idx="5">
                  <c:v>CTX-9</c:v>
                </c:pt>
                <c:pt idx="6">
                  <c:v>GES</c:v>
                </c:pt>
                <c:pt idx="7">
                  <c:v>OXA48</c:v>
                </c:pt>
                <c:pt idx="8">
                  <c:v>KPC</c:v>
                </c:pt>
                <c:pt idx="9">
                  <c:v>VIM</c:v>
                </c:pt>
                <c:pt idx="10">
                  <c:v>NDM</c:v>
                </c:pt>
                <c:pt idx="11">
                  <c:v>OXA23</c:v>
                </c:pt>
              </c:strCache>
            </c:strRef>
          </c:cat>
          <c:val>
            <c:numRef>
              <c:f>SupplementaryFigure1!$B$4:$M$4</c:f>
              <c:numCache>
                <c:formatCode>General</c:formatCode>
                <c:ptCount val="12"/>
                <c:pt idx="0">
                  <c:v>11</c:v>
                </c:pt>
                <c:pt idx="1">
                  <c:v>34</c:v>
                </c:pt>
                <c:pt idx="2">
                  <c:v>14</c:v>
                </c:pt>
                <c:pt idx="3">
                  <c:v>11</c:v>
                </c:pt>
                <c:pt idx="4">
                  <c:v>0</c:v>
                </c:pt>
                <c:pt idx="5">
                  <c:v>4</c:v>
                </c:pt>
                <c:pt idx="6">
                  <c:v>0</c:v>
                </c:pt>
                <c:pt idx="7">
                  <c:v>0</c:v>
                </c:pt>
                <c:pt idx="8">
                  <c:v>4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2526-41E4-820E-7EF1E157EA9A}"/>
            </c:ext>
          </c:extLst>
        </c:ser>
        <c:ser>
          <c:idx val="2"/>
          <c:order val="2"/>
          <c:tx>
            <c:strRef>
              <c:f>SupplementaryFigure1!$A$5</c:f>
              <c:strCache>
                <c:ptCount val="1"/>
                <c:pt idx="0">
                  <c:v>P. aeruginosa</c:v>
                </c:pt>
              </c:strCache>
            </c:strRef>
          </c:tx>
          <c:spPr>
            <a:solidFill>
              <a:schemeClr val="bg2">
                <a:lumMod val="50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SupplementaryFigure1!$B$2:$M$2</c:f>
              <c:strCache>
                <c:ptCount val="12"/>
                <c:pt idx="0">
                  <c:v>TEM</c:v>
                </c:pt>
                <c:pt idx="1">
                  <c:v>SHV</c:v>
                </c:pt>
                <c:pt idx="2">
                  <c:v>OXA1</c:v>
                </c:pt>
                <c:pt idx="3">
                  <c:v>CTX-1</c:v>
                </c:pt>
                <c:pt idx="4">
                  <c:v>CTX-2</c:v>
                </c:pt>
                <c:pt idx="5">
                  <c:v>CTX-9</c:v>
                </c:pt>
                <c:pt idx="6">
                  <c:v>GES</c:v>
                </c:pt>
                <c:pt idx="7">
                  <c:v>OXA48</c:v>
                </c:pt>
                <c:pt idx="8">
                  <c:v>KPC</c:v>
                </c:pt>
                <c:pt idx="9">
                  <c:v>VIM</c:v>
                </c:pt>
                <c:pt idx="10">
                  <c:v>NDM</c:v>
                </c:pt>
                <c:pt idx="11">
                  <c:v>OXA23</c:v>
                </c:pt>
              </c:strCache>
            </c:strRef>
          </c:cat>
          <c:val>
            <c:numRef>
              <c:f>SupplementaryFigure1!$B$5:$M$5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2526-41E4-820E-7EF1E157EA9A}"/>
            </c:ext>
          </c:extLst>
        </c:ser>
        <c:ser>
          <c:idx val="3"/>
          <c:order val="3"/>
          <c:tx>
            <c:strRef>
              <c:f>SupplementaryFigure1!$A$6</c:f>
              <c:strCache>
                <c:ptCount val="1"/>
                <c:pt idx="0">
                  <c:v>E. cloacae</c:v>
                </c:pt>
              </c:strCache>
            </c:strRef>
          </c:tx>
          <c:spPr>
            <a:solidFill>
              <a:srgbClr val="FFFF00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SupplementaryFigure1!$B$2:$M$2</c:f>
              <c:strCache>
                <c:ptCount val="12"/>
                <c:pt idx="0">
                  <c:v>TEM</c:v>
                </c:pt>
                <c:pt idx="1">
                  <c:v>SHV</c:v>
                </c:pt>
                <c:pt idx="2">
                  <c:v>OXA1</c:v>
                </c:pt>
                <c:pt idx="3">
                  <c:v>CTX-1</c:v>
                </c:pt>
                <c:pt idx="4">
                  <c:v>CTX-2</c:v>
                </c:pt>
                <c:pt idx="5">
                  <c:v>CTX-9</c:v>
                </c:pt>
                <c:pt idx="6">
                  <c:v>GES</c:v>
                </c:pt>
                <c:pt idx="7">
                  <c:v>OXA48</c:v>
                </c:pt>
                <c:pt idx="8">
                  <c:v>KPC</c:v>
                </c:pt>
                <c:pt idx="9">
                  <c:v>VIM</c:v>
                </c:pt>
                <c:pt idx="10">
                  <c:v>NDM</c:v>
                </c:pt>
                <c:pt idx="11">
                  <c:v>OXA23</c:v>
                </c:pt>
              </c:strCache>
            </c:strRef>
          </c:cat>
          <c:val>
            <c:numRef>
              <c:f>SupplementaryFigure1!$B$6:$M$6</c:f>
              <c:numCache>
                <c:formatCode>General</c:formatCode>
                <c:ptCount val="12"/>
                <c:pt idx="0">
                  <c:v>3</c:v>
                </c:pt>
                <c:pt idx="1">
                  <c:v>2</c:v>
                </c:pt>
                <c:pt idx="2">
                  <c:v>3</c:v>
                </c:pt>
                <c:pt idx="3">
                  <c:v>3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1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2526-41E4-820E-7EF1E157EA9A}"/>
            </c:ext>
          </c:extLst>
        </c:ser>
        <c:ser>
          <c:idx val="4"/>
          <c:order val="4"/>
          <c:tx>
            <c:strRef>
              <c:f>SupplementaryFigure1!$A$7</c:f>
              <c:strCache>
                <c:ptCount val="1"/>
                <c:pt idx="0">
                  <c:v>A. baumannii</c:v>
                </c:pt>
              </c:strCache>
            </c:strRef>
          </c:tx>
          <c:spPr>
            <a:solidFill>
              <a:srgbClr val="FF33CC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SupplementaryFigure1!$B$2:$M$2</c:f>
              <c:strCache>
                <c:ptCount val="12"/>
                <c:pt idx="0">
                  <c:v>TEM</c:v>
                </c:pt>
                <c:pt idx="1">
                  <c:v>SHV</c:v>
                </c:pt>
                <c:pt idx="2">
                  <c:v>OXA1</c:v>
                </c:pt>
                <c:pt idx="3">
                  <c:v>CTX-1</c:v>
                </c:pt>
                <c:pt idx="4">
                  <c:v>CTX-2</c:v>
                </c:pt>
                <c:pt idx="5">
                  <c:v>CTX-9</c:v>
                </c:pt>
                <c:pt idx="6">
                  <c:v>GES</c:v>
                </c:pt>
                <c:pt idx="7">
                  <c:v>OXA48</c:v>
                </c:pt>
                <c:pt idx="8">
                  <c:v>KPC</c:v>
                </c:pt>
                <c:pt idx="9">
                  <c:v>VIM</c:v>
                </c:pt>
                <c:pt idx="10">
                  <c:v>NDM</c:v>
                </c:pt>
                <c:pt idx="11">
                  <c:v>OXA23</c:v>
                </c:pt>
              </c:strCache>
            </c:strRef>
          </c:cat>
          <c:val>
            <c:numRef>
              <c:f>SupplementaryFigure1!$B$7:$M$7</c:f>
              <c:numCache>
                <c:formatCode>General</c:formatCode>
                <c:ptCount val="12"/>
                <c:pt idx="0">
                  <c:v>1</c:v>
                </c:pt>
                <c:pt idx="1">
                  <c:v>0</c:v>
                </c:pt>
                <c:pt idx="2">
                  <c:v>0</c:v>
                </c:pt>
                <c:pt idx="3">
                  <c:v>1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2526-41E4-820E-7EF1E157EA9A}"/>
            </c:ext>
          </c:extLst>
        </c:ser>
        <c:ser>
          <c:idx val="5"/>
          <c:order val="5"/>
          <c:tx>
            <c:strRef>
              <c:f>SupplementaryFigure1!$A$8</c:f>
              <c:strCache>
                <c:ptCount val="1"/>
                <c:pt idx="0">
                  <c:v>Others</c:v>
                </c:pt>
              </c:strCache>
            </c:strRef>
          </c:tx>
          <c:spPr>
            <a:solidFill>
              <a:srgbClr val="7030A0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SupplementaryFigure1!$B$2:$M$2</c:f>
              <c:strCache>
                <c:ptCount val="12"/>
                <c:pt idx="0">
                  <c:v>TEM</c:v>
                </c:pt>
                <c:pt idx="1">
                  <c:v>SHV</c:v>
                </c:pt>
                <c:pt idx="2">
                  <c:v>OXA1</c:v>
                </c:pt>
                <c:pt idx="3">
                  <c:v>CTX-1</c:v>
                </c:pt>
                <c:pt idx="4">
                  <c:v>CTX-2</c:v>
                </c:pt>
                <c:pt idx="5">
                  <c:v>CTX-9</c:v>
                </c:pt>
                <c:pt idx="6">
                  <c:v>GES</c:v>
                </c:pt>
                <c:pt idx="7">
                  <c:v>OXA48</c:v>
                </c:pt>
                <c:pt idx="8">
                  <c:v>KPC</c:v>
                </c:pt>
                <c:pt idx="9">
                  <c:v>VIM</c:v>
                </c:pt>
                <c:pt idx="10">
                  <c:v>NDM</c:v>
                </c:pt>
                <c:pt idx="11">
                  <c:v>OXA23</c:v>
                </c:pt>
              </c:strCache>
            </c:strRef>
          </c:cat>
          <c:val>
            <c:numRef>
              <c:f>SupplementaryFigure1!$B$8:$M$8</c:f>
              <c:numCache>
                <c:formatCode>General</c:formatCode>
                <c:ptCount val="12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0</c:v>
                </c:pt>
                <c:pt idx="5">
                  <c:v>0</c:v>
                </c:pt>
                <c:pt idx="6">
                  <c:v>1</c:v>
                </c:pt>
                <c:pt idx="7">
                  <c:v>0</c:v>
                </c:pt>
                <c:pt idx="8">
                  <c:v>0</c:v>
                </c:pt>
                <c:pt idx="9">
                  <c:v>1</c:v>
                </c:pt>
                <c:pt idx="10">
                  <c:v>0</c:v>
                </c:pt>
                <c:pt idx="11">
                  <c:v>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2526-41E4-820E-7EF1E157EA9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25792256"/>
        <c:axId val="125794176"/>
      </c:barChart>
      <c:catAx>
        <c:axId val="12579225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200">
                    <a:solidFill>
                      <a:schemeClr val="tx1"/>
                    </a:solidFill>
                  </a:defRPr>
                </a:pPr>
                <a:r>
                  <a:rPr lang="pt-BR" sz="1200" b="1">
                    <a:solidFill>
                      <a:schemeClr val="tx1"/>
                    </a:solidFill>
                  </a:rPr>
                  <a:t>Resistance</a:t>
                </a:r>
                <a:r>
                  <a:rPr lang="pt-BR" sz="1200" b="1" baseline="0">
                    <a:solidFill>
                      <a:schemeClr val="tx1"/>
                    </a:solidFill>
                  </a:rPr>
                  <a:t> genes</a:t>
                </a:r>
                <a:endParaRPr lang="pt-BR" sz="1200" b="1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0.41853795841814001"/>
              <c:y val="0.85733167243257724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t-BR"/>
          </a:p>
        </c:txPr>
        <c:crossAx val="125794176"/>
        <c:crosses val="autoZero"/>
        <c:auto val="1"/>
        <c:lblAlgn val="ctr"/>
        <c:lblOffset val="100"/>
        <c:noMultiLvlLbl val="0"/>
      </c:catAx>
      <c:valAx>
        <c:axId val="12579417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vert="horz"/>
              <a:lstStyle/>
              <a:p>
                <a:pPr>
                  <a:defRPr sz="1200">
                    <a:solidFill>
                      <a:schemeClr val="tx1"/>
                    </a:solidFill>
                  </a:defRPr>
                </a:pPr>
                <a:r>
                  <a:rPr lang="pt-BR" sz="1200">
                    <a:solidFill>
                      <a:schemeClr val="tx1"/>
                    </a:solidFill>
                  </a:rPr>
                  <a:t>Percentage</a:t>
                </a:r>
              </a:p>
            </c:rich>
          </c:tx>
          <c:layout/>
          <c:overlay val="0"/>
        </c:title>
        <c:numFmt formatCode="0%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t-BR"/>
          </a:p>
        </c:txPr>
        <c:crossAx val="125792256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legend>
      <c:legendPos val="b"/>
      <c:legendEntry>
        <c:idx val="0"/>
        <c:txPr>
          <a:bodyPr rot="0" spcFirstLastPara="1" vertOverflow="ellipsis" vert="horz" wrap="square" anchor="ctr" anchorCtr="1"/>
          <a:lstStyle/>
          <a:p>
            <a:pPr>
              <a:defRPr sz="1200" b="0" i="1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t-BR"/>
          </a:p>
        </c:txPr>
      </c:legendEntry>
      <c:legendEntry>
        <c:idx val="1"/>
        <c:txPr>
          <a:bodyPr rot="0" spcFirstLastPara="1" vertOverflow="ellipsis" vert="horz" wrap="square" anchor="ctr" anchorCtr="1"/>
          <a:lstStyle/>
          <a:p>
            <a:pPr>
              <a:defRPr sz="1200" b="0" i="1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t-BR"/>
          </a:p>
        </c:txPr>
      </c:legendEntry>
      <c:legendEntry>
        <c:idx val="2"/>
        <c:txPr>
          <a:bodyPr rot="0" spcFirstLastPara="1" vertOverflow="ellipsis" vert="horz" wrap="square" anchor="ctr" anchorCtr="1"/>
          <a:lstStyle/>
          <a:p>
            <a:pPr>
              <a:defRPr sz="1200" b="0" i="1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t-BR"/>
          </a:p>
        </c:txPr>
      </c:legendEntry>
      <c:legendEntry>
        <c:idx val="3"/>
        <c:txPr>
          <a:bodyPr rot="0" spcFirstLastPara="1" vertOverflow="ellipsis" vert="horz" wrap="square" anchor="ctr" anchorCtr="1"/>
          <a:lstStyle/>
          <a:p>
            <a:pPr>
              <a:defRPr sz="1200" b="0" i="1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t-BR"/>
          </a:p>
        </c:txPr>
      </c:legendEntry>
      <c:legendEntry>
        <c:idx val="4"/>
        <c:txPr>
          <a:bodyPr rot="0" spcFirstLastPara="1" vertOverflow="ellipsis" vert="horz" wrap="square" anchor="ctr" anchorCtr="1"/>
          <a:lstStyle/>
          <a:p>
            <a:pPr>
              <a:defRPr sz="1200" b="0" i="1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t-BR"/>
          </a:p>
        </c:txPr>
      </c:legendEntry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pt-BR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pt-BR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 smtClean="0"/>
              <a:t>Clique para editar o estilo do subtítulo mestre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8DC7-3154-445B-BDD1-20F610C66306}" type="datetimeFigureOut">
              <a:rPr lang="pt-BR" smtClean="0"/>
              <a:t>16/01/2019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418EF6-2565-4DBA-BF52-95D3DADC0EB4}" type="slidenum">
              <a:rPr lang="pt-BR" smtClean="0"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8DC7-3154-445B-BDD1-20F610C66306}" type="datetimeFigureOut">
              <a:rPr lang="pt-BR" smtClean="0"/>
              <a:t>16/01/2019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418EF6-2565-4DBA-BF52-95D3DADC0EB4}" type="slidenum">
              <a:rPr lang="pt-BR" smtClean="0"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8DC7-3154-445B-BDD1-20F610C66306}" type="datetimeFigureOut">
              <a:rPr lang="pt-BR" smtClean="0"/>
              <a:t>16/01/2019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418EF6-2565-4DBA-BF52-95D3DADC0EB4}" type="slidenum">
              <a:rPr lang="pt-BR" smtClean="0"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8DC7-3154-445B-BDD1-20F610C66306}" type="datetimeFigureOut">
              <a:rPr lang="pt-BR" smtClean="0"/>
              <a:t>16/01/2019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418EF6-2565-4DBA-BF52-95D3DADC0EB4}" type="slidenum">
              <a:rPr lang="pt-BR" smtClean="0"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8DC7-3154-445B-BDD1-20F610C66306}" type="datetimeFigureOut">
              <a:rPr lang="pt-BR" smtClean="0"/>
              <a:t>16/01/2019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418EF6-2565-4DBA-BF52-95D3DADC0EB4}" type="slidenum">
              <a:rPr lang="pt-BR" smtClean="0"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8DC7-3154-445B-BDD1-20F610C66306}" type="datetimeFigureOut">
              <a:rPr lang="pt-BR" smtClean="0"/>
              <a:t>16/01/2019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418EF6-2565-4DBA-BF52-95D3DADC0EB4}" type="slidenum">
              <a:rPr lang="pt-BR" smtClean="0"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8DC7-3154-445B-BDD1-20F610C66306}" type="datetimeFigureOut">
              <a:rPr lang="pt-BR" smtClean="0"/>
              <a:t>16/01/2019</a:t>
            </a:fld>
            <a:endParaRPr lang="pt-BR"/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418EF6-2565-4DBA-BF52-95D3DADC0EB4}" type="slidenum">
              <a:rPr lang="pt-BR" smtClean="0"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8DC7-3154-445B-BDD1-20F610C66306}" type="datetimeFigureOut">
              <a:rPr lang="pt-BR" smtClean="0"/>
              <a:t>16/01/2019</a:t>
            </a:fld>
            <a:endParaRPr lang="pt-BR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418EF6-2565-4DBA-BF52-95D3DADC0EB4}" type="slidenum">
              <a:rPr lang="pt-BR" smtClean="0"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8DC7-3154-445B-BDD1-20F610C66306}" type="datetimeFigureOut">
              <a:rPr lang="pt-BR" smtClean="0"/>
              <a:t>16/01/2019</a:t>
            </a:fld>
            <a:endParaRPr lang="pt-BR"/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418EF6-2565-4DBA-BF52-95D3DADC0EB4}" type="slidenum">
              <a:rPr lang="pt-BR" smtClean="0"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8DC7-3154-445B-BDD1-20F610C66306}" type="datetimeFigureOut">
              <a:rPr lang="pt-BR" smtClean="0"/>
              <a:t>16/01/2019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418EF6-2565-4DBA-BF52-95D3DADC0EB4}" type="slidenum">
              <a:rPr lang="pt-BR" smtClean="0"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8DC7-3154-445B-BDD1-20F610C66306}" type="datetimeFigureOut">
              <a:rPr lang="pt-BR" smtClean="0"/>
              <a:t>16/01/2019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418EF6-2565-4DBA-BF52-95D3DADC0EB4}" type="slidenum">
              <a:rPr lang="pt-BR" smtClean="0"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888DC7-3154-445B-BDD1-20F610C66306}" type="datetimeFigureOut">
              <a:rPr lang="pt-BR" smtClean="0"/>
              <a:t>16/01/2019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418EF6-2565-4DBA-BF52-95D3DADC0EB4}" type="slidenum">
              <a:rPr lang="pt-BR" smtClean="0"/>
              <a:t>‹nº›</a:t>
            </a:fld>
            <a:endParaRPr lang="pt-B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Gráfico 1">
            <a:extLst>
              <a:ext uri="{FF2B5EF4-FFF2-40B4-BE49-F238E27FC236}">
                <a16:creationId xmlns:xdr="http://schemas.openxmlformats.org/drawingml/2006/spreadsheetDrawing" xmlns="" xmlns:a16="http://schemas.microsoft.com/office/drawing/2014/main" xmlns:lc="http://schemas.openxmlformats.org/drawingml/2006/lockedCanvas" id="{00000000-0008-0000-0000-000009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78073169"/>
              </p:ext>
            </p:extLst>
          </p:nvPr>
        </p:nvGraphicFramePr>
        <p:xfrm>
          <a:off x="1187624" y="764704"/>
          <a:ext cx="7033644" cy="43534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429305017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3</Words>
  <Application>Microsoft Office PowerPoint</Application>
  <PresentationFormat>Apresentação no Ecrã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os diapositivos</vt:lpstr>
      </vt:variant>
      <vt:variant>
        <vt:i4>1</vt:i4>
      </vt:variant>
    </vt:vector>
  </HeadingPairs>
  <TitlesOfParts>
    <vt:vector size="2" baseType="lpstr">
      <vt:lpstr>Tema do Office</vt:lpstr>
      <vt:lpstr>Apresentação do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oebu</dc:creator>
  <cp:lastModifiedBy>Joice</cp:lastModifiedBy>
  <cp:revision>3</cp:revision>
  <dcterms:created xsi:type="dcterms:W3CDTF">2018-12-16T16:02:44Z</dcterms:created>
  <dcterms:modified xsi:type="dcterms:W3CDTF">2019-01-16T12:22:34Z</dcterms:modified>
</cp:coreProperties>
</file>